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01_3B095DE6.xml" ContentType="application/vnd.ms-powerpoint.comment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43697EE-5ECB-C8B8-7E51-685EB3751A96}" name="Jiyeon Noh" initials="JN" userId="89c904322dadf215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omments/modernComment_101_3B095DE6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249F3892-23BB-4340-ABB3-EBFC919023C1}" authorId="{943697EE-5ECB-C8B8-7E51-685EB3751A96}" created="2022-02-16T19:23:10.264">
    <pc:sldMkLst xmlns:pc="http://schemas.microsoft.com/office/powerpoint/2013/main/command">
      <pc:docMk/>
      <pc:sldMk cId="990469606" sldId="257"/>
    </pc:sldMkLst>
    <p188:txBody>
      <a:bodyPr/>
      <a:lstStyle/>
      <a:p>
        <a:r>
          <a:rPr lang="en-US"/>
          <a:t>(figure Y axis) Reletive expression--&gt;Relative expression</a:t>
        </a:r>
      </a:p>
    </p188:txBody>
  </p188:cm>
</p188:cmLst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812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224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695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166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225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660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917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959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477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203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233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54A6B3-F94A-4A6F-8E1B-70800B6ECE54}" type="datetimeFigureOut">
              <a:rPr lang="en-US" smtClean="0"/>
              <a:t>2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B7996-75B5-4427-9990-05AABA688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115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microsoft.com/office/2018/10/relationships/comments" Target="../comments/modernComment_101_3B095DE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F99E26-C76A-44E0-9661-F73FA0A990A9}"/>
              </a:ext>
            </a:extLst>
          </p:cNvPr>
          <p:cNvSpPr txBox="1"/>
          <p:nvPr/>
        </p:nvSpPr>
        <p:spPr>
          <a:xfrm>
            <a:off x="609599" y="106681"/>
            <a:ext cx="3845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1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5CDE21-45F3-45FE-BF2E-247739392E62}"/>
              </a:ext>
            </a:extLst>
          </p:cNvPr>
          <p:cNvSpPr txBox="1"/>
          <p:nvPr/>
        </p:nvSpPr>
        <p:spPr>
          <a:xfrm>
            <a:off x="2026025" y="3624328"/>
            <a:ext cx="4572000" cy="14672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l Figure S1. 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on GHS-R gene expression significantly increases by DSS exposure in aging mice.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Young (4–6-month-old) or 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ged (18-month-old) male mice were exposed to 2% (</a:t>
            </a:r>
            <a:r>
              <a:rPr lang="en-US" sz="1200" i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200" i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DSS for 7 consecutive days. GHS-R expression in colon </a:t>
            </a:r>
            <a:r>
              <a:rPr lang="en-US" sz="12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as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creased </a:t>
            </a:r>
            <a:r>
              <a:rPr lang="en-US" sz="12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der 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SS-induced colitis and aged mice showed more pronounced increase.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 = 5-10 in young group, n=4-5 in aged group.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##, p&lt;0.01, DSS vs. control.</a:t>
            </a:r>
          </a:p>
        </p:txBody>
      </p:sp>
      <p:sp>
        <p:nvSpPr>
          <p:cNvPr id="9" name="Rectangle 2">
            <a:extLst>
              <a:ext uri="{FF2B5EF4-FFF2-40B4-BE49-F238E27FC236}">
                <a16:creationId xmlns:a16="http://schemas.microsoft.com/office/drawing/2014/main" id="{DFA1715B-6A2F-455E-8E89-5DF0BAE147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6705" y="1004047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0CF9FFC3-BB60-4BC5-88A4-3D716A7B9E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6189" y="959597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FBFBFBA6-0AD0-4F1D-BEC5-0C9FB4DFC082}"/>
              </a:ext>
            </a:extLst>
          </p:cNvPr>
          <p:cNvGrpSpPr/>
          <p:nvPr/>
        </p:nvGrpSpPr>
        <p:grpSpPr>
          <a:xfrm>
            <a:off x="2106705" y="1004047"/>
            <a:ext cx="3520285" cy="2580698"/>
            <a:chOff x="2088167" y="687124"/>
            <a:chExt cx="3520285" cy="2580698"/>
          </a:xfrm>
        </p:grpSpPr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4C9AA210-AEF4-4CFB-9F0F-1D8B4A07A1C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39245188"/>
                </p:ext>
              </p:extLst>
            </p:nvPr>
          </p:nvGraphicFramePr>
          <p:xfrm>
            <a:off x="2106705" y="1004047"/>
            <a:ext cx="1630363" cy="2263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77" r:id="rId3" imgW="2175580" imgH="3009807" progId="Prism8.Document">
                    <p:embed/>
                  </p:oleObj>
                </mc:Choice>
                <mc:Fallback>
                  <p:oleObj r:id="rId3" imgW="2175580" imgH="3009807" progId="Prism8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2D692BC4-7403-46FE-B69A-B18D979C93D8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06705" y="1004047"/>
                          <a:ext cx="1630363" cy="2263775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1EECE1AC-FD50-4870-9281-97F07F4C976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51740377"/>
                </p:ext>
              </p:extLst>
            </p:nvPr>
          </p:nvGraphicFramePr>
          <p:xfrm>
            <a:off x="4016189" y="959597"/>
            <a:ext cx="1592263" cy="2308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78" r:id="rId5" imgW="2175580" imgH="3147026" progId="Prism8.Document">
                    <p:embed/>
                  </p:oleObj>
                </mc:Choice>
                <mc:Fallback>
                  <p:oleObj r:id="rId5" imgW="2175580" imgH="3147026" progId="Prism8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480660E6-0F4C-49B8-A282-5521A42C085A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016189" y="959597"/>
                          <a:ext cx="1592263" cy="2308225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8F7858C-1049-4F6C-8763-ED860701D54A}"/>
                </a:ext>
              </a:extLst>
            </p:cNvPr>
            <p:cNvSpPr txBox="1"/>
            <p:nvPr/>
          </p:nvSpPr>
          <p:spPr>
            <a:xfrm>
              <a:off x="2088167" y="687124"/>
              <a:ext cx="3318767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b="1" dirty="0"/>
                <a:t>A                                  B</a:t>
              </a:r>
            </a:p>
            <a:p>
              <a:r>
                <a:rPr lang="en-US" b="1" dirty="0"/>
                <a:t>             </a:t>
              </a:r>
              <a:r>
                <a:rPr lang="en-US" sz="1200" b="1" dirty="0"/>
                <a:t>Young                                            Aged </a:t>
              </a:r>
              <a:endParaRPr lang="en-US" b="1" dirty="0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EEB0F289-DE3B-4CB4-BFE7-779B8D3E9F95}"/>
                </a:ext>
              </a:extLst>
            </p:cNvPr>
            <p:cNvSpPr/>
            <p:nvPr/>
          </p:nvSpPr>
          <p:spPr>
            <a:xfrm>
              <a:off x="2747682" y="1266922"/>
              <a:ext cx="573742" cy="205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990469606"/>
      </p:ext>
    </p:extLst>
  </p:cSld>
  <p:clrMapOvr>
    <a:masterClrMapping/>
  </p:clrMapOvr>
  <p:extLst mod="1">
    <p:ext uri="{6950BFC3-D8DA-4A85-94F7-54DA5524770B}">
      <p188:commentRel xmlns:p188="http://schemas.microsoft.com/office/powerpoint/2018/8/main" xmlns="" r:id="rId7"/>
    </p:ext>
  </p:extLs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5AB32E0-DCA7-4478-B7A2-38BEAF68CCD3}"/>
              </a:ext>
            </a:extLst>
          </p:cNvPr>
          <p:cNvSpPr txBox="1"/>
          <p:nvPr/>
        </p:nvSpPr>
        <p:spPr>
          <a:xfrm>
            <a:off x="609599" y="106681"/>
            <a:ext cx="3845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Figure S2 </a:t>
            </a:r>
            <a:endParaRPr lang="en-US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B95527C-FF17-4978-8952-8A6A25DB39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7482" y="147021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42980F-C373-469F-99AB-B150B464BAFA}"/>
              </a:ext>
            </a:extLst>
          </p:cNvPr>
          <p:cNvSpPr txBox="1"/>
          <p:nvPr/>
        </p:nvSpPr>
        <p:spPr>
          <a:xfrm>
            <a:off x="1461248" y="3964900"/>
            <a:ext cx="6284258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l Figure S2.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lon length and weight changes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young and aged WT mice under DSS-induced colitis. Young (4–6-month-old) or aged (18-month-old) male WT mice were exposed to 2% (</a:t>
            </a:r>
            <a:r>
              <a:rPr lang="en-US" sz="12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</a:t>
            </a:r>
            <a:r>
              <a:rPr lang="en-US" sz="12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DSS for 7 consecutive days. (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Colon length, (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Colon weight, on termination day.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#, p&lt;0.05, ##, p&lt;0.01, ### p&lt;0.001 aged vs. young. </a:t>
            </a:r>
          </a:p>
          <a:p>
            <a:endParaRPr lang="en-US" sz="1200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FF406E1A-FAC4-4862-B203-40C154B18FF2}"/>
              </a:ext>
            </a:extLst>
          </p:cNvPr>
          <p:cNvGrpSpPr/>
          <p:nvPr/>
        </p:nvGrpSpPr>
        <p:grpSpPr>
          <a:xfrm>
            <a:off x="1147482" y="1151869"/>
            <a:ext cx="6759389" cy="2612281"/>
            <a:chOff x="1147482" y="1151869"/>
            <a:chExt cx="6759389" cy="2612281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7C76306A-2353-4FFB-94F3-EFFECA40770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42453024"/>
                </p:ext>
              </p:extLst>
            </p:nvPr>
          </p:nvGraphicFramePr>
          <p:xfrm>
            <a:off x="1147482" y="1151869"/>
            <a:ext cx="6759389" cy="261228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0" r:id="rId3" imgW="8115298" imgH="3136221" progId="Prism8.Document">
                    <p:embed/>
                  </p:oleObj>
                </mc:Choice>
                <mc:Fallback>
                  <p:oleObj r:id="rId3" imgW="8115298" imgH="3136221" progId="Prism8.Document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47482" y="1151869"/>
                          <a:ext cx="6759389" cy="2612281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1390C70-7139-4F12-B1C4-84B859A7C94B}"/>
                </a:ext>
              </a:extLst>
            </p:cNvPr>
            <p:cNvSpPr txBox="1"/>
            <p:nvPr/>
          </p:nvSpPr>
          <p:spPr>
            <a:xfrm>
              <a:off x="1147482" y="1151869"/>
              <a:ext cx="37866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                                                             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46364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</TotalTime>
  <Words>186</Words>
  <Application>Microsoft Office PowerPoint</Application>
  <PresentationFormat>On-screen Show (4:3)</PresentationFormat>
  <Paragraphs>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0" baseType="lpstr">
      <vt:lpstr>SimSun</vt:lpstr>
      <vt:lpstr>Arial</vt:lpstr>
      <vt:lpstr>Calibri</vt:lpstr>
      <vt:lpstr>Calibri Light</vt:lpstr>
      <vt:lpstr>Palatino Linotype</vt:lpstr>
      <vt:lpstr>Times New Roman</vt:lpstr>
      <vt:lpstr>Office Theme</vt:lpstr>
      <vt:lpstr>Prism8.Document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xiang Sun</dc:creator>
  <cp:lastModifiedBy>MDPI</cp:lastModifiedBy>
  <cp:revision>6</cp:revision>
  <dcterms:created xsi:type="dcterms:W3CDTF">2022-02-12T21:59:56Z</dcterms:created>
  <dcterms:modified xsi:type="dcterms:W3CDTF">2022-02-17T10:38:13Z</dcterms:modified>
</cp:coreProperties>
</file>